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906000" cy="6858000" type="A4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83" userDrawn="1">
          <p15:clr>
            <a:srgbClr val="A4A3A4"/>
          </p15:clr>
        </p15:guide>
        <p15:guide id="2" pos="81" userDrawn="1">
          <p15:clr>
            <a:srgbClr val="A4A3A4"/>
          </p15:clr>
        </p15:guide>
        <p15:guide id="3" orient="horz" pos="20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70" autoAdjust="0"/>
    <p:restoredTop sz="94660"/>
  </p:normalViewPr>
  <p:slideViewPr>
    <p:cSldViewPr snapToGrid="0">
      <p:cViewPr>
        <p:scale>
          <a:sx n="90" d="100"/>
          <a:sy n="90" d="100"/>
        </p:scale>
        <p:origin x="-2448" y="-552"/>
      </p:cViewPr>
      <p:guideLst>
        <p:guide orient="horz" pos="2183"/>
        <p:guide orient="horz" pos="2027"/>
        <p:guide pos="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2F3F5-0ECE-4623-8A46-209D33A92747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741363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D8DD9-1C24-4B35-9623-BDD78EDCC8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461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25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7465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25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019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2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157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447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583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839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990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04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72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3" name="Rectangle 342"/>
          <p:cNvSpPr/>
          <p:nvPr/>
        </p:nvSpPr>
        <p:spPr>
          <a:xfrm>
            <a:off x="143604" y="5906874"/>
            <a:ext cx="960284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+mj-lt"/>
                <a:cs typeface="Times New Roman" panose="02020603050405020304" pitchFamily="18" charset="0"/>
              </a:rPr>
              <a:t>Supplementary Figure 3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– IVIS images of lungs excised from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hHGF-ki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mice that received intra-pancreatic injection of HPAF-II cells. </a:t>
            </a:r>
            <a:r>
              <a:rPr lang="en-US" sz="1200" dirty="0">
                <a:cs typeface="Times New Roman" panose="02020603050405020304" pitchFamily="18" charset="0"/>
              </a:rPr>
              <a:t>Mice </a:t>
            </a:r>
            <a:r>
              <a:rPr lang="en-US" sz="1200" dirty="0"/>
              <a:t>were treated by intraperitoneal injection of VEHICLE or the indicated molecules.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Images reported in panel A and B correspond to the experiments quantified in Fig.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4C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D, respectively.</a:t>
            </a:r>
            <a:endParaRPr lang="en-US" sz="1200" dirty="0">
              <a:latin typeface="+mj-lt"/>
              <a:cs typeface="Times New Roman" panose="02020603050405020304" pitchFamily="18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101234" y="651382"/>
            <a:ext cx="9777183" cy="3855215"/>
            <a:chOff x="101234" y="651382"/>
            <a:chExt cx="9777183" cy="3855215"/>
          </a:xfrm>
        </p:grpSpPr>
        <p:sp>
          <p:nvSpPr>
            <p:cNvPr id="348" name="CasellaDiTesto 347"/>
            <p:cNvSpPr txBox="1"/>
            <p:nvPr/>
          </p:nvSpPr>
          <p:spPr>
            <a:xfrm>
              <a:off x="235848" y="651382"/>
              <a:ext cx="365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/>
                <a:t>A</a:t>
              </a:r>
              <a:endParaRPr lang="it-IT" sz="1600" dirty="0"/>
            </a:p>
          </p:txBody>
        </p:sp>
        <p:sp>
          <p:nvSpPr>
            <p:cNvPr id="347" name="CasellaDiTesto 346"/>
            <p:cNvSpPr txBox="1"/>
            <p:nvPr/>
          </p:nvSpPr>
          <p:spPr>
            <a:xfrm>
              <a:off x="5108817" y="651382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B</a:t>
              </a:r>
              <a:endParaRPr lang="en-GB" sz="1600" dirty="0"/>
            </a:p>
          </p:txBody>
        </p:sp>
        <p:sp>
          <p:nvSpPr>
            <p:cNvPr id="513" name="TextBox 5"/>
            <p:cNvSpPr txBox="1"/>
            <p:nvPr/>
          </p:nvSpPr>
          <p:spPr>
            <a:xfrm>
              <a:off x="4576387" y="1055971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VEHICLE</a:t>
              </a:r>
              <a:endParaRPr lang="it-IT" sz="1400" dirty="0"/>
            </a:p>
          </p:txBody>
        </p:sp>
        <p:sp>
          <p:nvSpPr>
            <p:cNvPr id="96" name="TextBox 12">
              <a:extLst>
                <a:ext uri="{FF2B5EF4-FFF2-40B4-BE49-F238E27FC236}">
                  <a16:creationId xmlns:a16="http://schemas.microsoft.com/office/drawing/2014/main" xmlns="" id="{33C012E8-FD3F-429E-93ED-AA21360520C9}"/>
                </a:ext>
              </a:extLst>
            </p:cNvPr>
            <p:cNvSpPr txBox="1"/>
            <p:nvPr/>
          </p:nvSpPr>
          <p:spPr>
            <a:xfrm>
              <a:off x="6520769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64E+06</a:t>
              </a:r>
              <a:endParaRPr lang="it-IT" sz="1100" dirty="0"/>
            </a:p>
          </p:txBody>
        </p:sp>
        <p:sp>
          <p:nvSpPr>
            <p:cNvPr id="97" name="TextBox 32">
              <a:extLst>
                <a:ext uri="{FF2B5EF4-FFF2-40B4-BE49-F238E27FC236}">
                  <a16:creationId xmlns:a16="http://schemas.microsoft.com/office/drawing/2014/main" xmlns="" id="{615783A9-72BD-4FF3-99B1-573FD2D45ADC}"/>
                </a:ext>
              </a:extLst>
            </p:cNvPr>
            <p:cNvSpPr txBox="1"/>
            <p:nvPr/>
          </p:nvSpPr>
          <p:spPr>
            <a:xfrm>
              <a:off x="7839991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2.49E+07</a:t>
              </a:r>
              <a:endParaRPr lang="it-IT" sz="1100" dirty="0"/>
            </a:p>
          </p:txBody>
        </p:sp>
        <p:sp>
          <p:nvSpPr>
            <p:cNvPr id="98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7181379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13E+07</a:t>
              </a:r>
              <a:endParaRPr lang="it-IT" sz="1100" dirty="0"/>
            </a:p>
          </p:txBody>
        </p:sp>
        <p:sp>
          <p:nvSpPr>
            <p:cNvPr id="99" name="TextBox 58">
              <a:extLst>
                <a:ext uri="{FF2B5EF4-FFF2-40B4-BE49-F238E27FC236}">
                  <a16:creationId xmlns:a16="http://schemas.microsoft.com/office/drawing/2014/main" xmlns="" id="{30BE3640-52AF-497C-BEF9-ECE4A09F7B07}"/>
                </a:ext>
              </a:extLst>
            </p:cNvPr>
            <p:cNvSpPr txBox="1"/>
            <p:nvPr/>
          </p:nvSpPr>
          <p:spPr>
            <a:xfrm>
              <a:off x="4522649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3.68E+06</a:t>
              </a:r>
              <a:endParaRPr lang="it-IT" sz="1100" dirty="0"/>
            </a:p>
          </p:txBody>
        </p:sp>
        <p:sp>
          <p:nvSpPr>
            <p:cNvPr id="100" name="TextBox 59">
              <a:extLst>
                <a:ext uri="{FF2B5EF4-FFF2-40B4-BE49-F238E27FC236}">
                  <a16:creationId xmlns:a16="http://schemas.microsoft.com/office/drawing/2014/main" xmlns="" id="{918EF17C-B16C-45FB-8066-3374AFB6C04D}"/>
                </a:ext>
              </a:extLst>
            </p:cNvPr>
            <p:cNvSpPr txBox="1"/>
            <p:nvPr/>
          </p:nvSpPr>
          <p:spPr>
            <a:xfrm>
              <a:off x="5201947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8.39E+05</a:t>
              </a:r>
              <a:endParaRPr lang="it-IT" sz="1100" dirty="0"/>
            </a:p>
          </p:txBody>
        </p:sp>
        <p:sp>
          <p:nvSpPr>
            <p:cNvPr id="101" name="TextBox 60">
              <a:extLst>
                <a:ext uri="{FF2B5EF4-FFF2-40B4-BE49-F238E27FC236}">
                  <a16:creationId xmlns:a16="http://schemas.microsoft.com/office/drawing/2014/main" xmlns="" id="{74754137-D0F4-4D98-B0FB-F5CDB1E3F479}"/>
                </a:ext>
              </a:extLst>
            </p:cNvPr>
            <p:cNvSpPr txBox="1"/>
            <p:nvPr/>
          </p:nvSpPr>
          <p:spPr>
            <a:xfrm>
              <a:off x="5861785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49E+07</a:t>
              </a:r>
              <a:endParaRPr lang="it-IT" sz="1100" dirty="0"/>
            </a:p>
          </p:txBody>
        </p:sp>
        <p:pic>
          <p:nvPicPr>
            <p:cNvPr id="102" name="Picture 2" descr="K:\## Gene Transfer and Therapy\Elisa Vigna\Met-HGF-ott2018\Shared\in vivo\EXP_Fusion_Proteins\HPAF\EXP_20181219_HPAF_L6\20199123\Immagini per revisione\Vehicle\A1 dx JER20190123114623_001.PNG"/>
            <p:cNvPicPr>
              <a:picLocks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76" t="35830" r="43673" b="43834"/>
            <a:stretch/>
          </p:blipFill>
          <p:spPr bwMode="auto">
            <a:xfrm>
              <a:off x="4603645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" name="Picture 3" descr="K:\## Gene Transfer and Therapy\Elisa Vigna\Met-HGF-ott2018\Shared\in vivo\EXP_Fusion_Proteins\HPAF\EXP_20181219_HPAF_L6\20199123\Immagini per revisione\Vehicle\A1 sx JER20190123113539_001.PNG"/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31" t="29989" r="47541" b="42753"/>
            <a:stretch/>
          </p:blipFill>
          <p:spPr bwMode="auto">
            <a:xfrm>
              <a:off x="5261076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" name="Picture 4" descr="K:\## Gene Transfer and Therapy\Elisa Vigna\Met-HGF-ott2018\Shared\in vivo\EXP_Fusion_Proteins\HPAF\EXP_20181219_HPAF_L6\20199123\Immagini per revisione\Vehicle\A1 dxsx JER20190123111613_001.PNG"/>
            <p:cNvPicPr>
              <a:picLocks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76" t="15928" r="55663" b="48594"/>
            <a:stretch/>
          </p:blipFill>
          <p:spPr bwMode="auto">
            <a:xfrm>
              <a:off x="5918508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5" name="Picture 5" descr="K:\## Gene Transfer and Therapy\Elisa Vigna\Met-HGF-ott2018\Shared\in vivo\EXP_Fusion_Proteins\HPAF\EXP_20181219_HPAF_L6\20199123\Immagini per revisione\Vehicle\A1 2sx JER20190123112525_001.PNG"/>
            <p:cNvPicPr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20" t="35830" r="47154" b="36263"/>
            <a:stretch/>
          </p:blipFill>
          <p:spPr bwMode="auto">
            <a:xfrm>
              <a:off x="6575939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" name="Picture 6" descr="K:\## Gene Transfer and Therapy\Elisa Vigna\Met-HGF-ott2018\Shared\in vivo\EXP_Fusion_Proteins\HPAF\EXP_20181219_HPAF_L6\20199123\Immagini per revisione\Vehicle\A2 dx JER20190123122141_001.PNG"/>
            <p:cNvPicPr>
              <a:picLocks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29989" r="47411" b="39292"/>
            <a:stretch/>
          </p:blipFill>
          <p:spPr bwMode="auto">
            <a:xfrm>
              <a:off x="7233371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7" name="Picture 7" descr="K:\## Gene Transfer and Therapy\Elisa Vigna\Met-HGF-ott2018\Shared\in vivo\EXP_Fusion_Proteins\HPAF\EXP_20181219_HPAF_L6\20199123\Immagini per revisione\Vehicle\A2 sx JER20190123120951_001.PNG"/>
            <p:cNvPicPr>
              <a:picLocks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76" t="30206" r="46122" b="36479"/>
            <a:stretch/>
          </p:blipFill>
          <p:spPr bwMode="auto">
            <a:xfrm>
              <a:off x="7890802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8" name="Picture 8" descr="K:\## Gene Transfer and Therapy\Elisa Vigna\Met-HGF-ott2018\Shared\in vivo\EXP_Fusion_Proteins\HPAF\EXP_20181219_HPAF_L6\20199123\Immagini per revisione\Vehicle\A2 dxsx JER20190123123213_001.PNG"/>
            <p:cNvPicPr>
              <a:picLocks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01" t="23499" r="45349" b="50541"/>
            <a:stretch/>
          </p:blipFill>
          <p:spPr bwMode="auto">
            <a:xfrm>
              <a:off x="8548231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9" name="Picture 9" descr="K:\## Gene Transfer and Therapy\Elisa Vigna\Met-HGF-ott2018\Shared\in vivo\EXP_Fusion_Proteins\HPAF\EXP_20181219_HPAF_L6\20199123\Immagini per revisione\Vehicle\A2 NL JER20190123120121_001.PNG"/>
            <p:cNvPicPr>
              <a:picLocks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57" t="37993" r="50764" b="32369"/>
            <a:stretch/>
          </p:blipFill>
          <p:spPr bwMode="auto">
            <a:xfrm>
              <a:off x="9206254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0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9158348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2.68E+07</a:t>
              </a:r>
              <a:endParaRPr lang="it-IT" sz="1100" dirty="0"/>
            </a:p>
          </p:txBody>
        </p:sp>
        <p:sp>
          <p:nvSpPr>
            <p:cNvPr id="111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8495702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9.32E+04</a:t>
              </a:r>
              <a:endParaRPr lang="it-IT" sz="1100" dirty="0"/>
            </a:p>
          </p:txBody>
        </p:sp>
        <p:sp>
          <p:nvSpPr>
            <p:cNvPr id="528" name="TextBox 32"/>
            <p:cNvSpPr txBox="1"/>
            <p:nvPr/>
          </p:nvSpPr>
          <p:spPr>
            <a:xfrm>
              <a:off x="4523222" y="2219719"/>
              <a:ext cx="8803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DecAb-L6</a:t>
              </a:r>
              <a:endParaRPr lang="it-IT" sz="1400" dirty="0"/>
            </a:p>
          </p:txBody>
        </p:sp>
        <p:pic>
          <p:nvPicPr>
            <p:cNvPr id="113" name="Picture 11" descr="K:\## Gene Transfer and Therapy\Elisa Vigna\Met-HGF-ott2018\Shared\in vivo\EXP_Fusion_Proteins\HPAF\EXP_20181219_HPAF_L6\20199123\Immagini per revisione\L6 K-M\C dx JER20190123150006_001.PNG"/>
            <p:cNvPicPr>
              <a:picLocks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82" t="28475" r="52182" b="44916"/>
            <a:stretch/>
          </p:blipFill>
          <p:spPr bwMode="auto">
            <a:xfrm>
              <a:off x="4603645" y="248779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4" name="Picture 12" descr="K:\## Gene Transfer and Therapy\Elisa Vigna\Met-HGF-ott2018\Shared\in vivo\EXP_Fusion_Proteins\HPAF\EXP_20181219_HPAF_L6\20199123\Immagini per revisione\L6 K-M\C sx JER20190123141807_001.PNG"/>
            <p:cNvPicPr>
              <a:picLocks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65" t="21985" r="48185" b="47945"/>
            <a:stretch/>
          </p:blipFill>
          <p:spPr bwMode="auto">
            <a:xfrm>
              <a:off x="5261076" y="248779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5" name="Picture 13" descr="K:\## Gene Transfer and Therapy\Elisa Vigna\Met-HGF-ott2018\Shared\in vivo\EXP_Fusion_Proteins\HPAF\EXP_20181219_HPAF_L6\20199123\Immagini per revisione\L6 K-M\C dxsx JER20190123140830_001.PNG"/>
            <p:cNvPicPr>
              <a:picLocks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07" t="34532" r="51795" b="40806"/>
            <a:stretch/>
          </p:blipFill>
          <p:spPr bwMode="auto">
            <a:xfrm>
              <a:off x="5918508" y="248779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6" name="Picture 14" descr="K:\## Gene Transfer and Therapy\Elisa Vigna\Met-HGF-ott2018\Shared\in vivo\EXP_Fusion_Proteins\HPAF\EXP_20181219_HPAF_L6\20199123\Immagini per revisione\L6 K-M\C 2dx JER20190123142821_001.PNG"/>
            <p:cNvPicPr>
              <a:picLocks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07" t="25230" r="51795" b="49675"/>
            <a:stretch/>
          </p:blipFill>
          <p:spPr bwMode="auto">
            <a:xfrm>
              <a:off x="6575939" y="248779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7" name="Picture 15" descr="K:\## Gene Transfer and Therapy\Elisa Vigna\Met-HGF-ott2018\Shared\in vivo\EXP_Fusion_Proteins\HPAF\EXP_20181219_HPAF_L6\20199123\Immagini per revisione\L6 K-M\C 2sx JER20190123143809_001.PNG"/>
            <p:cNvPicPr>
              <a:picLocks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44" t="40590" r="47670" b="31936"/>
            <a:stretch/>
          </p:blipFill>
          <p:spPr bwMode="auto">
            <a:xfrm>
              <a:off x="7233371" y="248779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8" name="Picture 16" descr="K:\## Gene Transfer and Therapy\Elisa Vigna\Met-HGF-ott2018\Shared\in vivo\EXP_Fusion_Proteins\HPAF\EXP_20181219_HPAF_L6\20199123\Immagini per revisione\L6 K-M\C NL JER20190123144925_001.PNG"/>
            <p:cNvPicPr>
              <a:picLocks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86" t="21552" r="45091" b="50108"/>
            <a:stretch/>
          </p:blipFill>
          <p:spPr bwMode="auto">
            <a:xfrm>
              <a:off x="7890802" y="248779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5" name="TextBox 12">
              <a:extLst>
                <a:ext uri="{FF2B5EF4-FFF2-40B4-BE49-F238E27FC236}">
                  <a16:creationId xmlns:a16="http://schemas.microsoft.com/office/drawing/2014/main" xmlns="" id="{33C012E8-FD3F-429E-93ED-AA21360520C9}"/>
                </a:ext>
              </a:extLst>
            </p:cNvPr>
            <p:cNvSpPr txBox="1"/>
            <p:nvPr/>
          </p:nvSpPr>
          <p:spPr>
            <a:xfrm>
              <a:off x="6523060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2.90E+06</a:t>
              </a:r>
              <a:endParaRPr lang="it-IT" sz="1100" dirty="0"/>
            </a:p>
          </p:txBody>
        </p:sp>
        <p:sp>
          <p:nvSpPr>
            <p:cNvPr id="126" name="TextBox 32">
              <a:extLst>
                <a:ext uri="{FF2B5EF4-FFF2-40B4-BE49-F238E27FC236}">
                  <a16:creationId xmlns:a16="http://schemas.microsoft.com/office/drawing/2014/main" xmlns="" id="{615783A9-72BD-4FF3-99B1-573FD2D45ADC}"/>
                </a:ext>
              </a:extLst>
            </p:cNvPr>
            <p:cNvSpPr txBox="1"/>
            <p:nvPr/>
          </p:nvSpPr>
          <p:spPr>
            <a:xfrm>
              <a:off x="7186810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4.94E+06</a:t>
              </a:r>
              <a:endParaRPr lang="it-IT" sz="1100" dirty="0"/>
            </a:p>
          </p:txBody>
        </p:sp>
        <p:sp>
          <p:nvSpPr>
            <p:cNvPr id="127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7846998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6.00E+06</a:t>
              </a:r>
              <a:endParaRPr lang="it-IT" sz="1100" dirty="0"/>
            </a:p>
          </p:txBody>
        </p:sp>
        <p:sp>
          <p:nvSpPr>
            <p:cNvPr id="128" name="TextBox 58">
              <a:extLst>
                <a:ext uri="{FF2B5EF4-FFF2-40B4-BE49-F238E27FC236}">
                  <a16:creationId xmlns:a16="http://schemas.microsoft.com/office/drawing/2014/main" xmlns="" id="{30BE3640-52AF-497C-BEF9-ECE4A09F7B07}"/>
                </a:ext>
              </a:extLst>
            </p:cNvPr>
            <p:cNvSpPr txBox="1"/>
            <p:nvPr/>
          </p:nvSpPr>
          <p:spPr>
            <a:xfrm>
              <a:off x="4532401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3.37E+07</a:t>
              </a:r>
              <a:endParaRPr lang="it-IT" sz="1100" dirty="0"/>
            </a:p>
          </p:txBody>
        </p:sp>
        <p:sp>
          <p:nvSpPr>
            <p:cNvPr id="129" name="TextBox 59">
              <a:extLst>
                <a:ext uri="{FF2B5EF4-FFF2-40B4-BE49-F238E27FC236}">
                  <a16:creationId xmlns:a16="http://schemas.microsoft.com/office/drawing/2014/main" xmlns="" id="{918EF17C-B16C-45FB-8066-3374AFB6C04D}"/>
                </a:ext>
              </a:extLst>
            </p:cNvPr>
            <p:cNvSpPr txBox="1"/>
            <p:nvPr/>
          </p:nvSpPr>
          <p:spPr>
            <a:xfrm>
              <a:off x="5194245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5.20E+06</a:t>
              </a:r>
              <a:endParaRPr lang="it-IT" sz="1100" dirty="0"/>
            </a:p>
          </p:txBody>
        </p:sp>
        <p:sp>
          <p:nvSpPr>
            <p:cNvPr id="130" name="TextBox 60">
              <a:extLst>
                <a:ext uri="{FF2B5EF4-FFF2-40B4-BE49-F238E27FC236}">
                  <a16:creationId xmlns:a16="http://schemas.microsoft.com/office/drawing/2014/main" xmlns="" id="{74754137-D0F4-4D98-B0FB-F5CDB1E3F479}"/>
                </a:ext>
              </a:extLst>
            </p:cNvPr>
            <p:cNvSpPr txBox="1"/>
            <p:nvPr/>
          </p:nvSpPr>
          <p:spPr>
            <a:xfrm>
              <a:off x="5852083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2.43E+06</a:t>
              </a:r>
              <a:endParaRPr lang="it-IT" sz="1100" dirty="0"/>
            </a:p>
          </p:txBody>
        </p:sp>
        <p:sp>
          <p:nvSpPr>
            <p:cNvPr id="539" name="TextBox 51"/>
            <p:cNvSpPr txBox="1"/>
            <p:nvPr/>
          </p:nvSpPr>
          <p:spPr>
            <a:xfrm>
              <a:off x="4544488" y="3382602"/>
              <a:ext cx="8803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AbDec-L6</a:t>
              </a:r>
              <a:endParaRPr lang="it-IT" sz="1400" dirty="0"/>
            </a:p>
          </p:txBody>
        </p:sp>
        <p:sp>
          <p:nvSpPr>
            <p:cNvPr id="138" name="TextBox 12">
              <a:extLst>
                <a:ext uri="{FF2B5EF4-FFF2-40B4-BE49-F238E27FC236}">
                  <a16:creationId xmlns:a16="http://schemas.microsoft.com/office/drawing/2014/main" xmlns="" id="{33C012E8-FD3F-429E-93ED-AA21360520C9}"/>
                </a:ext>
              </a:extLst>
            </p:cNvPr>
            <p:cNvSpPr txBox="1"/>
            <p:nvPr/>
          </p:nvSpPr>
          <p:spPr>
            <a:xfrm>
              <a:off x="6529210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7.24E+05</a:t>
              </a:r>
              <a:endParaRPr lang="it-IT" sz="1100" dirty="0"/>
            </a:p>
          </p:txBody>
        </p:sp>
        <p:sp>
          <p:nvSpPr>
            <p:cNvPr id="139" name="TextBox 32">
              <a:extLst>
                <a:ext uri="{FF2B5EF4-FFF2-40B4-BE49-F238E27FC236}">
                  <a16:creationId xmlns:a16="http://schemas.microsoft.com/office/drawing/2014/main" xmlns="" id="{615783A9-72BD-4FF3-99B1-573FD2D45ADC}"/>
                </a:ext>
              </a:extLst>
            </p:cNvPr>
            <p:cNvSpPr txBox="1"/>
            <p:nvPr/>
          </p:nvSpPr>
          <p:spPr>
            <a:xfrm>
              <a:off x="7177322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92E+06</a:t>
              </a:r>
              <a:endParaRPr lang="it-IT" sz="1100" dirty="0"/>
            </a:p>
          </p:txBody>
        </p:sp>
        <p:sp>
          <p:nvSpPr>
            <p:cNvPr id="140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7835838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21E+07</a:t>
              </a:r>
              <a:endParaRPr lang="it-IT" sz="1100" dirty="0"/>
            </a:p>
          </p:txBody>
        </p:sp>
        <p:sp>
          <p:nvSpPr>
            <p:cNvPr id="141" name="TextBox 58">
              <a:extLst>
                <a:ext uri="{FF2B5EF4-FFF2-40B4-BE49-F238E27FC236}">
                  <a16:creationId xmlns:a16="http://schemas.microsoft.com/office/drawing/2014/main" xmlns="" id="{30BE3640-52AF-497C-BEF9-ECE4A09F7B07}"/>
                </a:ext>
              </a:extLst>
            </p:cNvPr>
            <p:cNvSpPr txBox="1"/>
            <p:nvPr/>
          </p:nvSpPr>
          <p:spPr>
            <a:xfrm>
              <a:off x="4554088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5.73E+06</a:t>
              </a:r>
              <a:endParaRPr lang="it-IT" sz="1100" dirty="0"/>
            </a:p>
          </p:txBody>
        </p:sp>
        <p:sp>
          <p:nvSpPr>
            <p:cNvPr id="142" name="TextBox 59">
              <a:extLst>
                <a:ext uri="{FF2B5EF4-FFF2-40B4-BE49-F238E27FC236}">
                  <a16:creationId xmlns:a16="http://schemas.microsoft.com/office/drawing/2014/main" xmlns="" id="{918EF17C-B16C-45FB-8066-3374AFB6C04D}"/>
                </a:ext>
              </a:extLst>
            </p:cNvPr>
            <p:cNvSpPr txBox="1"/>
            <p:nvPr/>
          </p:nvSpPr>
          <p:spPr>
            <a:xfrm>
              <a:off x="5205278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4.26E+06</a:t>
              </a:r>
              <a:endParaRPr lang="it-IT" sz="1100" dirty="0"/>
            </a:p>
          </p:txBody>
        </p:sp>
        <p:sp>
          <p:nvSpPr>
            <p:cNvPr id="143" name="TextBox 60">
              <a:extLst>
                <a:ext uri="{FF2B5EF4-FFF2-40B4-BE49-F238E27FC236}">
                  <a16:creationId xmlns:a16="http://schemas.microsoft.com/office/drawing/2014/main" xmlns="" id="{74754137-D0F4-4D98-B0FB-F5CDB1E3F479}"/>
                </a:ext>
              </a:extLst>
            </p:cNvPr>
            <p:cNvSpPr txBox="1"/>
            <p:nvPr/>
          </p:nvSpPr>
          <p:spPr>
            <a:xfrm>
              <a:off x="5866089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05E+07</a:t>
              </a:r>
              <a:endParaRPr lang="it-IT" sz="1100" dirty="0"/>
            </a:p>
          </p:txBody>
        </p:sp>
        <p:pic>
          <p:nvPicPr>
            <p:cNvPr id="144" name="Picture 17" descr="K:\## Gene Transfer and Therapy\Elisa Vigna\Met-HGF-ott2018\Shared\in vivo\EXP_Fusion_Proteins\HPAF\EXP_20181219_HPAF_L6\20199123\Immagini per revisione\L6 M-K\D dx JER20190123105705_001.PNG"/>
            <p:cNvPicPr>
              <a:picLocks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52" t="23283" r="50119" b="45998"/>
            <a:stretch/>
          </p:blipFill>
          <p:spPr bwMode="auto">
            <a:xfrm>
              <a:off x="4603645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5" name="Picture 18" descr="K:\## Gene Transfer and Therapy\Elisa Vigna\Met-HGF-ott2018\Shared\in vivo\EXP_Fusion_Proteins\HPAF\EXP_20181219_HPAF_L6\20199123\Immagini per revisione\L6 M-K\D sx JER20190123101356_SEQ.PNG"/>
            <p:cNvPicPr>
              <a:picLocks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49" t="29437" r="44507" b="42605"/>
            <a:stretch/>
          </p:blipFill>
          <p:spPr bwMode="auto">
            <a:xfrm>
              <a:off x="5261076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6" name="Picture 19" descr="K:\## Gene Transfer and Therapy\Elisa Vigna\Met-HGF-ott2018\Shared\in vivo\EXP_Fusion_Proteins\HPAF\EXP_20181219_HPAF_L6\20199123\Immagini per revisione\L6 M-K\D dxsx JER20190123102524_001.PNG"/>
            <p:cNvPicPr>
              <a:picLocks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31" t="28908" r="46122" b="43402"/>
            <a:stretch/>
          </p:blipFill>
          <p:spPr bwMode="auto">
            <a:xfrm>
              <a:off x="5918508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7" name="Picture 20" descr="K:\## Gene Transfer and Therapy\Elisa Vigna\Met-HGF-ott2018\Shared\in vivo\EXP_Fusion_Proteins\HPAF\EXP_20181219_HPAF_L6\20199123\Immagini per revisione\L6 M-K\D 2dx JER20190123110654_001.PNG"/>
            <p:cNvPicPr>
              <a:picLocks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20471" r="47153" b="47296"/>
            <a:stretch/>
          </p:blipFill>
          <p:spPr bwMode="auto">
            <a:xfrm>
              <a:off x="6575939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8" name="Picture 21" descr="K:\## Gene Transfer and Therapy\Elisa Vigna\Met-HGF-ott2018\Shared\in vivo\EXP_Fusion_Proteins\HPAF\EXP_20181219_HPAF_L6\20199123\Immagini per revisione\L6 M-K\D 2sx JER20190123103529_001.PNG"/>
            <p:cNvPicPr>
              <a:picLocks noChangeArrowheads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570" t="31720" r="47927" b="39941"/>
            <a:stretch/>
          </p:blipFill>
          <p:spPr bwMode="auto">
            <a:xfrm>
              <a:off x="7233371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9" name="Picture 22" descr="K:\## Gene Transfer and Therapy\Elisa Vigna\Met-HGF-ott2018\Shared\in vivo\EXP_Fusion_Proteins\HPAF\EXP_20181219_HPAF_L6\20199123\Immagini per revisione\L6 M-K\D NL JER20190123104725_001.PNG"/>
            <p:cNvPicPr>
              <a:picLocks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55" t="22850" r="51409" b="45782"/>
            <a:stretch/>
          </p:blipFill>
          <p:spPr bwMode="auto">
            <a:xfrm>
              <a:off x="7890802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0" name="TextBox 44"/>
            <p:cNvSpPr txBox="1"/>
            <p:nvPr/>
          </p:nvSpPr>
          <p:spPr>
            <a:xfrm>
              <a:off x="101234" y="3386605"/>
              <a:ext cx="8899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AbDec-L1</a:t>
              </a:r>
              <a:endParaRPr lang="it-IT" sz="1400" dirty="0"/>
            </a:p>
          </p:txBody>
        </p:sp>
        <p:sp>
          <p:nvSpPr>
            <p:cNvPr id="179" name="TextBox 12">
              <a:extLst>
                <a:ext uri="{FF2B5EF4-FFF2-40B4-BE49-F238E27FC236}">
                  <a16:creationId xmlns:a16="http://schemas.microsoft.com/office/drawing/2014/main" xmlns="" id="{33C012E8-FD3F-429E-93ED-AA21360520C9}"/>
                </a:ext>
              </a:extLst>
            </p:cNvPr>
            <p:cNvSpPr txBox="1"/>
            <p:nvPr/>
          </p:nvSpPr>
          <p:spPr>
            <a:xfrm>
              <a:off x="2038882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0.00E+00</a:t>
              </a:r>
              <a:endParaRPr lang="it-IT" sz="1100" dirty="0"/>
            </a:p>
          </p:txBody>
        </p:sp>
        <p:sp>
          <p:nvSpPr>
            <p:cNvPr id="180" name="TextBox 32">
              <a:extLst>
                <a:ext uri="{FF2B5EF4-FFF2-40B4-BE49-F238E27FC236}">
                  <a16:creationId xmlns:a16="http://schemas.microsoft.com/office/drawing/2014/main" xmlns="" id="{615783A9-72BD-4FF3-99B1-573FD2D45ADC}"/>
                </a:ext>
              </a:extLst>
            </p:cNvPr>
            <p:cNvSpPr txBox="1"/>
            <p:nvPr/>
          </p:nvSpPr>
          <p:spPr>
            <a:xfrm>
              <a:off x="2696174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09E+05</a:t>
              </a:r>
              <a:endParaRPr lang="it-IT" sz="1100" dirty="0"/>
            </a:p>
          </p:txBody>
        </p:sp>
        <p:sp>
          <p:nvSpPr>
            <p:cNvPr id="181" name="TextBox 58">
              <a:extLst>
                <a:ext uri="{FF2B5EF4-FFF2-40B4-BE49-F238E27FC236}">
                  <a16:creationId xmlns:a16="http://schemas.microsoft.com/office/drawing/2014/main" xmlns="" id="{30BE3640-52AF-497C-BEF9-ECE4A09F7B07}"/>
                </a:ext>
              </a:extLst>
            </p:cNvPr>
            <p:cNvSpPr txBox="1"/>
            <p:nvPr/>
          </p:nvSpPr>
          <p:spPr>
            <a:xfrm>
              <a:off x="104178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0.00E+00</a:t>
              </a:r>
              <a:endParaRPr lang="it-IT" sz="1100" dirty="0"/>
            </a:p>
          </p:txBody>
        </p:sp>
        <p:sp>
          <p:nvSpPr>
            <p:cNvPr id="182" name="TextBox 59">
              <a:extLst>
                <a:ext uri="{FF2B5EF4-FFF2-40B4-BE49-F238E27FC236}">
                  <a16:creationId xmlns:a16="http://schemas.microsoft.com/office/drawing/2014/main" xmlns="" id="{918EF17C-B16C-45FB-8066-3374AFB6C04D}"/>
                </a:ext>
              </a:extLst>
            </p:cNvPr>
            <p:cNvSpPr txBox="1"/>
            <p:nvPr/>
          </p:nvSpPr>
          <p:spPr>
            <a:xfrm>
              <a:off x="732797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82E+04</a:t>
              </a:r>
              <a:endParaRPr lang="it-IT" sz="1100" dirty="0"/>
            </a:p>
          </p:txBody>
        </p:sp>
        <p:sp>
          <p:nvSpPr>
            <p:cNvPr id="183" name="TextBox 60">
              <a:extLst>
                <a:ext uri="{FF2B5EF4-FFF2-40B4-BE49-F238E27FC236}">
                  <a16:creationId xmlns:a16="http://schemas.microsoft.com/office/drawing/2014/main" xmlns="" id="{74754137-D0F4-4D98-B0FB-F5CDB1E3F479}"/>
                </a:ext>
              </a:extLst>
            </p:cNvPr>
            <p:cNvSpPr txBox="1"/>
            <p:nvPr/>
          </p:nvSpPr>
          <p:spPr>
            <a:xfrm>
              <a:off x="1402561" y="4244987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4.81E+04</a:t>
              </a:r>
              <a:endParaRPr lang="it-IT" sz="1100" dirty="0"/>
            </a:p>
          </p:txBody>
        </p:sp>
        <p:pic>
          <p:nvPicPr>
            <p:cNvPr id="195" name="Picture 29" descr="K:\## Gene Transfer and Therapy\Elisa Vigna\Met-HGF-ott2018\Shared\in vivo\EXP_Fusion_Proteins\HPAF\EXP_20190306\20190408\immagini per revisione\L3 K-M\B1 dx AAA20190409154209_001.PNG"/>
            <p:cNvPicPr>
              <a:picLocks noChangeArrowheads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403" t="8572" r="42513" b="61357"/>
            <a:stretch/>
          </p:blipFill>
          <p:spPr bwMode="auto">
            <a:xfrm>
              <a:off x="167559" y="2488032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6" name="Picture 30" descr="K:\## Gene Transfer and Therapy\Elisa Vigna\Met-HGF-ott2018\Shared\in vivo\EXP_Fusion_Proteins\HPAF\EXP_20190306\20190408\immagini per revisione\L3 K-M\B1 sx AAA20190409152202_001.PNG"/>
            <p:cNvPicPr>
              <a:picLocks noChangeArrowheads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75" t="26312" r="47799" b="48810"/>
            <a:stretch/>
          </p:blipFill>
          <p:spPr bwMode="auto">
            <a:xfrm>
              <a:off x="811792" y="2488032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7" name="Picture 31" descr="K:\## Gene Transfer and Therapy\Elisa Vigna\Met-HGF-ott2018\Shared\in vivo\EXP_Fusion_Proteins\HPAF\EXP_20190306\20190408\immagini per revisione\L3 K-M\B1 Nl AAA20190409153315_001.PNG"/>
            <p:cNvPicPr>
              <a:picLocks noChangeArrowheads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40" t="35181" r="44705" b="41887"/>
            <a:stretch/>
          </p:blipFill>
          <p:spPr bwMode="auto">
            <a:xfrm>
              <a:off x="1456024" y="2488032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8" name="Picture 32" descr="K:\## Gene Transfer and Therapy\Elisa Vigna\Met-HGF-ott2018\Shared\in vivo\EXP_Fusion_Proteins\HPAF\EXP_20190306\20190408\immagini per revisione\L3 K-M\B2 dx JER20190409150211_001.PNG"/>
            <p:cNvPicPr>
              <a:picLocks noChangeArrowheads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30" t="9221" r="45607" b="67848"/>
            <a:stretch/>
          </p:blipFill>
          <p:spPr bwMode="auto">
            <a:xfrm>
              <a:off x="2100257" y="2488032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9" name="Picture 33" descr="K:\## Gene Transfer and Therapy\Elisa Vigna\Met-HGF-ott2018\Shared\in vivo\EXP_Fusion_Proteins\HPAF\EXP_20190306\20190408\immagini per revisione\L3 K-M\B2 NL AAA20190409151646_001.PNG"/>
            <p:cNvPicPr>
              <a:picLocks noChangeArrowheads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117" t="7707" r="43157" b="70011"/>
            <a:stretch/>
          </p:blipFill>
          <p:spPr bwMode="auto">
            <a:xfrm>
              <a:off x="2744488" y="2488032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1" name="TextBox 45"/>
            <p:cNvSpPr txBox="1"/>
            <p:nvPr/>
          </p:nvSpPr>
          <p:spPr>
            <a:xfrm>
              <a:off x="111247" y="2215716"/>
              <a:ext cx="8899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DecAb-L1</a:t>
              </a:r>
              <a:endParaRPr lang="it-IT" sz="1400" dirty="0"/>
            </a:p>
          </p:txBody>
        </p:sp>
        <p:sp>
          <p:nvSpPr>
            <p:cNvPr id="190" name="TextBox 12">
              <a:extLst>
                <a:ext uri="{FF2B5EF4-FFF2-40B4-BE49-F238E27FC236}">
                  <a16:creationId xmlns:a16="http://schemas.microsoft.com/office/drawing/2014/main" xmlns="" id="{33C012E8-FD3F-429E-93ED-AA21360520C9}"/>
                </a:ext>
              </a:extLst>
            </p:cNvPr>
            <p:cNvSpPr txBox="1"/>
            <p:nvPr/>
          </p:nvSpPr>
          <p:spPr>
            <a:xfrm>
              <a:off x="2046004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7.31E+04</a:t>
              </a:r>
              <a:endParaRPr lang="it-IT" sz="1100" dirty="0"/>
            </a:p>
          </p:txBody>
        </p:sp>
        <p:sp>
          <p:nvSpPr>
            <p:cNvPr id="191" name="TextBox 32">
              <a:extLst>
                <a:ext uri="{FF2B5EF4-FFF2-40B4-BE49-F238E27FC236}">
                  <a16:creationId xmlns:a16="http://schemas.microsoft.com/office/drawing/2014/main" xmlns="" id="{615783A9-72BD-4FF3-99B1-573FD2D45ADC}"/>
                </a:ext>
              </a:extLst>
            </p:cNvPr>
            <p:cNvSpPr txBox="1"/>
            <p:nvPr/>
          </p:nvSpPr>
          <p:spPr>
            <a:xfrm>
              <a:off x="2695234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0.00E+00</a:t>
              </a:r>
              <a:endParaRPr lang="it-IT" sz="1100" dirty="0"/>
            </a:p>
          </p:txBody>
        </p:sp>
        <p:sp>
          <p:nvSpPr>
            <p:cNvPr id="192" name="TextBox 58">
              <a:extLst>
                <a:ext uri="{FF2B5EF4-FFF2-40B4-BE49-F238E27FC236}">
                  <a16:creationId xmlns:a16="http://schemas.microsoft.com/office/drawing/2014/main" xmlns="" id="{30BE3640-52AF-497C-BEF9-ECE4A09F7B07}"/>
                </a:ext>
              </a:extLst>
            </p:cNvPr>
            <p:cNvSpPr txBox="1"/>
            <p:nvPr/>
          </p:nvSpPr>
          <p:spPr>
            <a:xfrm>
              <a:off x="101234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3.01E+05</a:t>
              </a:r>
              <a:endParaRPr lang="it-IT" sz="1100" dirty="0"/>
            </a:p>
          </p:txBody>
        </p:sp>
        <p:sp>
          <p:nvSpPr>
            <p:cNvPr id="193" name="TextBox 59">
              <a:extLst>
                <a:ext uri="{FF2B5EF4-FFF2-40B4-BE49-F238E27FC236}">
                  <a16:creationId xmlns:a16="http://schemas.microsoft.com/office/drawing/2014/main" xmlns="" id="{918EF17C-B16C-45FB-8066-3374AFB6C04D}"/>
                </a:ext>
              </a:extLst>
            </p:cNvPr>
            <p:cNvSpPr txBox="1"/>
            <p:nvPr/>
          </p:nvSpPr>
          <p:spPr>
            <a:xfrm>
              <a:off x="744602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99E+04</a:t>
              </a:r>
              <a:endParaRPr lang="it-IT" sz="1100" dirty="0"/>
            </a:p>
          </p:txBody>
        </p:sp>
        <p:sp>
          <p:nvSpPr>
            <p:cNvPr id="194" name="TextBox 60">
              <a:extLst>
                <a:ext uri="{FF2B5EF4-FFF2-40B4-BE49-F238E27FC236}">
                  <a16:creationId xmlns:a16="http://schemas.microsoft.com/office/drawing/2014/main" xmlns="" id="{74754137-D0F4-4D98-B0FB-F5CDB1E3F479}"/>
                </a:ext>
              </a:extLst>
            </p:cNvPr>
            <p:cNvSpPr txBox="1"/>
            <p:nvPr/>
          </p:nvSpPr>
          <p:spPr>
            <a:xfrm>
              <a:off x="1390249" y="3078101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90E+05</a:t>
              </a:r>
              <a:endParaRPr lang="it-IT" sz="1100" dirty="0"/>
            </a:p>
          </p:txBody>
        </p:sp>
        <p:pic>
          <p:nvPicPr>
            <p:cNvPr id="200" name="Picture 2" descr="K:\## Gene Transfer and Therapy\Elisa Vigna\Met-HGF-ott2018\Shared\in vivo\EXP_Fusion_Proteins\HPAF\EXP_20190306\20190408\immagini per revisione\L3 M-K\C1 dx JER20190408162613_001.PNG"/>
            <p:cNvPicPr>
              <a:picLocks noChangeArrowheads="1"/>
            </p:cNvPicPr>
            <p:nvPr/>
          </p:nvPicPr>
          <p:blipFill rotWithShape="1"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403" t="40806" r="42126" b="30638"/>
            <a:stretch/>
          </p:blipFill>
          <p:spPr bwMode="auto">
            <a:xfrm>
              <a:off x="167559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1" name="Picture 3" descr="K:\## Gene Transfer and Therapy\Elisa Vigna\Met-HGF-ott2018\Shared\in vivo\EXP_Fusion_Proteins\HPAF\EXP_20190306\20190408\immagini per revisione\L3 M-K\C1 sx JER20190408164557_001.PNG"/>
            <p:cNvPicPr>
              <a:picLocks noChangeArrowheads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49" r="42513" b="62223"/>
            <a:stretch/>
          </p:blipFill>
          <p:spPr bwMode="auto">
            <a:xfrm>
              <a:off x="811791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2" name="Picture 4" descr="K:\## Gene Transfer and Therapy\Elisa Vigna\Met-HGF-ott2018\Shared\in vivo\EXP_Fusion_Proteins\HPAF\EXP_20190306\20190408\immagini per revisione\L3 M-K\C1 Nl JER20190408163418_001.PNG"/>
            <p:cNvPicPr>
              <a:picLocks noChangeArrowheads="1"/>
            </p:cNvPicPr>
            <p:nvPr/>
          </p:nvPicPr>
          <p:blipFill rotWithShape="1"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12" t="6841" r="46252" b="72823"/>
            <a:stretch/>
          </p:blipFill>
          <p:spPr bwMode="auto">
            <a:xfrm>
              <a:off x="1456024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3" name="Picture 5" descr="K:\## Gene Transfer and Therapy\Elisa Vigna\Met-HGF-ott2018\Shared\in vivo\EXP_Fusion_Proteins\HPAF\EXP_20190306\20190408\immagini per revisione\L3 M-K\C2 sx JER20190408161551_001.PNG"/>
            <p:cNvPicPr>
              <a:picLocks noChangeArrowheads="1"/>
            </p:cNvPicPr>
            <p:nvPr/>
          </p:nvPicPr>
          <p:blipFill rotWithShape="1"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88" t="4029" r="48443" b="67198"/>
            <a:stretch/>
          </p:blipFill>
          <p:spPr bwMode="auto">
            <a:xfrm>
              <a:off x="2100257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4" name="Picture 6" descr="K:\## Gene Transfer and Therapy\Elisa Vigna\Met-HGF-ott2018\Shared\in vivo\EXP_Fusion_Proteins\HPAF\EXP_20190306\20190408\immagini per revisione\L3 M-K\C2 dxsx JER20190408160458_001.PNG"/>
            <p:cNvPicPr>
              <a:picLocks noChangeArrowheads="1"/>
            </p:cNvPicPr>
            <p:nvPr/>
          </p:nvPicPr>
          <p:blipFill rotWithShape="1"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762" t="15062" r="46767" b="48594"/>
            <a:stretch/>
          </p:blipFill>
          <p:spPr bwMode="auto">
            <a:xfrm>
              <a:off x="2744488" y="3652959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1" name="TextBox 5"/>
            <p:cNvSpPr txBox="1"/>
            <p:nvPr/>
          </p:nvSpPr>
          <p:spPr>
            <a:xfrm>
              <a:off x="126765" y="1055971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VEHICLE</a:t>
              </a:r>
              <a:endParaRPr lang="it-IT" sz="1400" dirty="0"/>
            </a:p>
          </p:txBody>
        </p:sp>
        <p:sp>
          <p:nvSpPr>
            <p:cNvPr id="163" name="TextBox 12">
              <a:extLst>
                <a:ext uri="{FF2B5EF4-FFF2-40B4-BE49-F238E27FC236}">
                  <a16:creationId xmlns:a16="http://schemas.microsoft.com/office/drawing/2014/main" xmlns="" id="{33C012E8-FD3F-429E-93ED-AA21360520C9}"/>
                </a:ext>
              </a:extLst>
            </p:cNvPr>
            <p:cNvSpPr txBox="1"/>
            <p:nvPr/>
          </p:nvSpPr>
          <p:spPr>
            <a:xfrm>
              <a:off x="2088478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70E+04</a:t>
              </a:r>
              <a:endParaRPr lang="it-IT" sz="1100" dirty="0"/>
            </a:p>
          </p:txBody>
        </p:sp>
        <p:sp>
          <p:nvSpPr>
            <p:cNvPr id="164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2746253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59E+05</a:t>
              </a:r>
              <a:endParaRPr lang="it-IT" sz="1100" dirty="0"/>
            </a:p>
          </p:txBody>
        </p:sp>
        <p:sp>
          <p:nvSpPr>
            <p:cNvPr id="165" name="TextBox 58">
              <a:extLst>
                <a:ext uri="{FF2B5EF4-FFF2-40B4-BE49-F238E27FC236}">
                  <a16:creationId xmlns:a16="http://schemas.microsoft.com/office/drawing/2014/main" xmlns="" id="{30BE3640-52AF-497C-BEF9-ECE4A09F7B07}"/>
                </a:ext>
              </a:extLst>
            </p:cNvPr>
            <p:cNvSpPr txBox="1"/>
            <p:nvPr/>
          </p:nvSpPr>
          <p:spPr>
            <a:xfrm>
              <a:off x="101234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2.23E+05</a:t>
              </a:r>
              <a:endParaRPr lang="it-IT" sz="1100" dirty="0"/>
            </a:p>
          </p:txBody>
        </p:sp>
        <p:sp>
          <p:nvSpPr>
            <p:cNvPr id="166" name="TextBox 59">
              <a:extLst>
                <a:ext uri="{FF2B5EF4-FFF2-40B4-BE49-F238E27FC236}">
                  <a16:creationId xmlns:a16="http://schemas.microsoft.com/office/drawing/2014/main" xmlns="" id="{918EF17C-B16C-45FB-8066-3374AFB6C04D}"/>
                </a:ext>
              </a:extLst>
            </p:cNvPr>
            <p:cNvSpPr txBox="1"/>
            <p:nvPr/>
          </p:nvSpPr>
          <p:spPr>
            <a:xfrm>
              <a:off x="758496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94E+05</a:t>
              </a:r>
              <a:endParaRPr lang="it-IT" sz="1100" dirty="0"/>
            </a:p>
          </p:txBody>
        </p:sp>
        <p:sp>
          <p:nvSpPr>
            <p:cNvPr id="167" name="TextBox 60">
              <a:extLst>
                <a:ext uri="{FF2B5EF4-FFF2-40B4-BE49-F238E27FC236}">
                  <a16:creationId xmlns:a16="http://schemas.microsoft.com/office/drawing/2014/main" xmlns="" id="{74754137-D0F4-4D98-B0FB-F5CDB1E3F479}"/>
                </a:ext>
              </a:extLst>
            </p:cNvPr>
            <p:cNvSpPr txBox="1"/>
            <p:nvPr/>
          </p:nvSpPr>
          <p:spPr>
            <a:xfrm>
              <a:off x="1418026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1.17E+05</a:t>
              </a:r>
              <a:endParaRPr lang="it-IT" sz="1100" dirty="0"/>
            </a:p>
          </p:txBody>
        </p:sp>
        <p:pic>
          <p:nvPicPr>
            <p:cNvPr id="168" name="Picture 21" descr="K:\## Gene Transfer and Therapy\Elisa Vigna\Met-HGF-ott2018\Shared\in vivo\EXP_Fusion_Proteins\HPAF\EXP_20190306\20190408\immagini per revisione\Vehicle\A1 dx AAA20190409170807_001.PNG"/>
            <p:cNvPicPr>
              <a:picLocks noChangeArrowheads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31" t="5111" r="44962" b="66117"/>
            <a:stretch/>
          </p:blipFill>
          <p:spPr bwMode="auto">
            <a:xfrm>
              <a:off x="162104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9" name="Picture 23" descr="K:\## Gene Transfer and Therapy\Elisa Vigna\Met-HGF-ott2018\Shared\in vivo\EXP_Fusion_Proteins\HPAF\EXP_20190306\20190408\immagini per revisione\Vehicle\A1 dxsx AAA20190409165655_001.PNG"/>
            <p:cNvPicPr>
              <a:picLocks noChangeArrowheads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58" t="45566" r="46123" b="26095"/>
            <a:stretch/>
          </p:blipFill>
          <p:spPr bwMode="auto">
            <a:xfrm>
              <a:off x="1480528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0" name="Picture 26" descr="K:\## Gene Transfer and Therapy\Elisa Vigna\Met-HGF-ott2018\Shared\in vivo\EXP_Fusion_Proteins\HPAF\EXP_20190306\20190408\immagini per revisione\Vehicle\A2 sx AAA20190409160613_001.PNG"/>
            <p:cNvPicPr>
              <a:picLocks noChangeArrowheads="1"/>
            </p:cNvPicPr>
            <p:nvPr/>
          </p:nvPicPr>
          <p:blipFill rotWithShape="1"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88" t="34316" r="48186" b="34748"/>
            <a:stretch/>
          </p:blipFill>
          <p:spPr bwMode="auto">
            <a:xfrm>
              <a:off x="2798951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1" name="Picture 27" descr="K:\## Gene Transfer and Therapy\Elisa Vigna\Met-HGF-ott2018\Shared\in vivo\EXP_Fusion_Proteins\HPAF\EXP_20190306\20190408\immagini per revisione\Vehicle\A2 dxsx AAA20190409155355_001.PNG"/>
            <p:cNvPicPr>
              <a:picLocks noChangeArrowheads="1"/>
            </p:cNvPicPr>
            <p:nvPr/>
          </p:nvPicPr>
          <p:blipFill rotWithShape="1"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01" t="21552" r="46509" b="52055"/>
            <a:stretch/>
          </p:blipFill>
          <p:spPr bwMode="auto">
            <a:xfrm>
              <a:off x="3459700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2" name="TextBox 42">
              <a:extLst>
                <a:ext uri="{FF2B5EF4-FFF2-40B4-BE49-F238E27FC236}">
                  <a16:creationId xmlns:a16="http://schemas.microsoft.com/office/drawing/2014/main" xmlns="" id="{6F2BCFDA-B8A9-4A54-9495-5BB144ECE2CF}"/>
                </a:ext>
              </a:extLst>
            </p:cNvPr>
            <p:cNvSpPr txBox="1"/>
            <p:nvPr/>
          </p:nvSpPr>
          <p:spPr>
            <a:xfrm>
              <a:off x="3404940" y="1915218"/>
              <a:ext cx="7200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 smtClean="0"/>
                <a:t>5.42E+04</a:t>
              </a:r>
              <a:endParaRPr lang="it-IT" sz="1100" dirty="0"/>
            </a:p>
          </p:txBody>
        </p:sp>
        <p:pic>
          <p:nvPicPr>
            <p:cNvPr id="206" name="Picture 3" descr="K:\## Gene Transfer and Therapy\Elisa Vigna\Met-HGF-ott2018\Shared\in vivo\EXP_Fusion_Proteins\HPAF\EXP_20190306\20190408\cage A1\sx\lung AAA20190409163911_SEQ\AAA20190409163911_001\AAA20190409163911_001.PNG"/>
            <p:cNvPicPr>
              <a:picLocks noChangeArrowheads="1"/>
            </p:cNvPicPr>
            <p:nvPr/>
          </p:nvPicPr>
          <p:blipFill rotWithShape="1"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43" r="45736" b="77366"/>
            <a:stretch/>
          </p:blipFill>
          <p:spPr bwMode="auto">
            <a:xfrm>
              <a:off x="821316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7" name="Picture 5" descr="K:\## Gene Transfer and Therapy\Elisa Vigna\Met-HGF-ott2018\Shared\in vivo\EXP_Fusion_Proteins\HPAF\EXP_20190306\20190408\cage A1\NL\lung AAA20190409164605_SEQ\AAA20190409164605_001\AAA20190409164605_001.PNG"/>
            <p:cNvPicPr>
              <a:picLocks noChangeArrowheads="1"/>
            </p:cNvPicPr>
            <p:nvPr/>
          </p:nvPicPr>
          <p:blipFill rotWithShape="1"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10" t="34965" r="47025" b="45133"/>
            <a:stretch/>
          </p:blipFill>
          <p:spPr bwMode="auto">
            <a:xfrm>
              <a:off x="2139740" y="1324744"/>
              <a:ext cx="612000" cy="61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827832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98</Words>
  <Application>Microsoft Office PowerPoint</Application>
  <PresentationFormat>A4 Paper (210x297 mm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ourl</dc:creator>
  <cp:lastModifiedBy>Cristina Basilico</cp:lastModifiedBy>
  <cp:revision>270</cp:revision>
  <cp:lastPrinted>2020-07-16T13:47:19Z</cp:lastPrinted>
  <dcterms:created xsi:type="dcterms:W3CDTF">2020-06-04T13:45:57Z</dcterms:created>
  <dcterms:modified xsi:type="dcterms:W3CDTF">2020-12-18T14:24:11Z</dcterms:modified>
</cp:coreProperties>
</file>